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7" r:id="rId2"/>
    <p:sldId id="277" r:id="rId3"/>
    <p:sldId id="266" r:id="rId4"/>
    <p:sldId id="268" r:id="rId5"/>
    <p:sldId id="278" r:id="rId6"/>
    <p:sldId id="279" r:id="rId7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amamoto Ryohei" initials="YR" lastIdx="32" clrIdx="0">
    <p:extLst>
      <p:ext uri="{19B8F6BF-5375-455C-9EA6-DF929625EA0E}">
        <p15:presenceInfo xmlns:p15="http://schemas.microsoft.com/office/powerpoint/2012/main" userId="f0c63b0f7a1adbe5" providerId="Windows Live"/>
      </p:ext>
    </p:extLst>
  </p:cmAuthor>
  <p:cmAuthor id="2" name="岡野 弘" initials="岡野" lastIdx="4" clrIdx="1">
    <p:extLst>
      <p:ext uri="{19B8F6BF-5375-455C-9EA6-DF929625EA0E}">
        <p15:presenceInfo xmlns:p15="http://schemas.microsoft.com/office/powerpoint/2012/main" userId="b687e4c854f450a1" providerId="Windows Live"/>
      </p:ext>
    </p:extLst>
  </p:cmAuthor>
  <p:cmAuthor id="3" name="岡野　弘" initials="岡野　弘" lastIdx="2" clrIdx="2">
    <p:extLst>
      <p:ext uri="{19B8F6BF-5375-455C-9EA6-DF929625EA0E}">
        <p15:presenceInfo xmlns:p15="http://schemas.microsoft.com/office/powerpoint/2012/main" userId="S::okano.hiromu.a5@luke.ac.jp::be413691-3352-4249-9afe-ad69dd3b96d9" providerId="AD"/>
      </p:ext>
    </p:extLst>
  </p:cmAuthor>
  <p:cmAuthor id="4" name="山本　良平" initials="良山" lastIdx="4" clrIdx="3">
    <p:extLst>
      <p:ext uri="{19B8F6BF-5375-455C-9EA6-DF929625EA0E}">
        <p15:presenceInfo xmlns:p15="http://schemas.microsoft.com/office/powerpoint/2012/main" userId="S::yamamoto.ryohei@kameda.jp::3a7eb3b3-2540-439d-874f-27af8dc73b3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81370" autoAdjust="0"/>
  </p:normalViewPr>
  <p:slideViewPr>
    <p:cSldViewPr snapToGrid="0">
      <p:cViewPr varScale="1">
        <p:scale>
          <a:sx n="60" d="100"/>
          <a:sy n="60" d="100"/>
        </p:scale>
        <p:origin x="105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4A3645-A3CF-4162-8945-61B3B15B8D24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en-GB" altLang="ja-JP"/>
              <a:t>Click to edit Master text styles</a:t>
            </a:r>
          </a:p>
          <a:p>
            <a:pPr lvl="1"/>
            <a:r>
              <a:rPr kumimoji="1" lang="en-GB" altLang="ja-JP"/>
              <a:t>Second level</a:t>
            </a:r>
          </a:p>
          <a:p>
            <a:pPr lvl="2"/>
            <a:r>
              <a:rPr kumimoji="1" lang="en-GB" altLang="ja-JP"/>
              <a:t>Third level</a:t>
            </a:r>
          </a:p>
          <a:p>
            <a:pPr lvl="3"/>
            <a:r>
              <a:rPr kumimoji="1" lang="en-GB" altLang="ja-JP"/>
              <a:t>Fourth level</a:t>
            </a:r>
          </a:p>
          <a:p>
            <a:pPr lvl="4"/>
            <a:r>
              <a:rPr kumimoji="1" lang="en-GB" altLang="ja-JP"/>
              <a:t>Fifth level</a:t>
            </a:r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BF1194-6468-454E-8BD6-3A451D8A68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47317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7BF1194-6468-454E-8BD6-3A451D8A686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90767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67269A1D-5371-382F-933D-17D6F8A61D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61A98841-9E87-1B8D-0EF8-679A65F4A3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A476AA5A-BFD6-0962-F637-2C7132294E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524E6-2FC0-4AD0-B79C-85473C9E6013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F79F63E7-224E-152A-AEFE-7F3A4C0A52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8DA8BFBE-9983-9C45-C79D-54DD6E6A5A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CE5E8-1424-4A1B-95A2-E5BC78F17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74176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5E0C861-FFAB-54EB-4B2A-4D97DD0DCF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EB0B8A86-9F07-251A-1CA7-EF07ECDEA0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7F79E638-2BB4-67F9-7F60-982B53D6D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524E6-2FC0-4AD0-B79C-85473C9E6013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196CC1C1-086B-41F0-37AB-0B0869ACA9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3CE72AA6-C1DC-F3B0-C7F4-9FB922D159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CE5E8-1424-4A1B-95A2-E5BC78F17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6538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4E39C111-A0C4-5A7A-78A0-D44F0B8BB1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FC8B255A-127F-A8DE-C8D1-88876E9A04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78EC386D-6BE0-4D81-A5F0-9DF705EB48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524E6-2FC0-4AD0-B79C-85473C9E6013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69E103A3-E47F-45E3-D98E-C2519201DA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516FAD3-539A-CAF9-B01F-709718EB72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CE5E8-1424-4A1B-95A2-E5BC78F17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2576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863141C-1297-5A2F-653A-0B8349EEEF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2682B890-8595-EB82-5EC3-82A3FF68E4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49644D76-3D64-2E27-7A8A-20622FBB5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524E6-2FC0-4AD0-B79C-85473C9E6013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78C42810-61D5-02A6-654C-CA831EB490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64E792FA-EA0A-38DF-EAFB-9BDDF25BC8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CE5E8-1424-4A1B-95A2-E5BC78F17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2692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956E9452-1A8F-F1AA-47EF-E33F88EF92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4972AE41-FC20-2B1B-7AC3-A7F293B7E4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FBC64568-E0A9-DA65-D9DD-9EEFDB307D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524E6-2FC0-4AD0-B79C-85473C9E6013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0773B4AF-1552-6E17-CBF7-06E59A20DD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3C96657B-7E9F-F156-5FB0-7CB14FCC9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CE5E8-1424-4A1B-95A2-E5BC78F17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392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AB29844B-8BEA-F51E-A35A-BBD669EF1E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5C4BEBF9-52F0-5DDF-0547-A8DB3F0A53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0BB0B2DB-63CA-45E2-CF3C-00CB1C4565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570A233E-83D3-F9E4-D0E1-77AFE3C91C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524E6-2FC0-4AD0-B79C-85473C9E6013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101CBDB9-9A17-F5B0-987A-F1BB4E8AB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C446A1F2-D805-2B82-723A-A4AA2CBB48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CE5E8-1424-4A1B-95A2-E5BC78F17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2783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35A589C-81A7-7538-2091-CF3BC1701D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636294D6-F810-54AB-5312-1E1A9F0716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C4985E1D-6999-FE66-59E6-064EA7CEB0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7A7B3CF2-DAA6-F2F7-AB80-68574A452E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13984D6D-C87A-1548-02DC-D302C07C33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F657E040-7E59-C27E-19C7-A8FB4DB519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524E6-2FC0-4AD0-B79C-85473C9E6013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17E0325F-1480-5EFB-E7D4-6C2FFC6DCD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002D8C39-ED73-F8F3-A10F-64CCAEE796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CE5E8-1424-4A1B-95A2-E5BC78F17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7084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51263E14-B787-81A5-07BE-41E8818A1D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B6291598-F8EF-6481-7CD0-BF980CA40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524E6-2FC0-4AD0-B79C-85473C9E6013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70376F31-5713-A722-A6D3-4CE36A301C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D59CE17A-D98E-3A63-FC55-586F495453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CE5E8-1424-4A1B-95A2-E5BC78F17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8738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B06946BA-4CA3-8C2D-45C4-8893D1D6BB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524E6-2FC0-4AD0-B79C-85473C9E6013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7788898F-1031-FA11-1A79-4158CDBA00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3BD79862-6569-F73A-327B-7A6FB7CBE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CE5E8-1424-4A1B-95A2-E5BC78F17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5958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A3B5E7E1-4263-69C8-0FB8-63134789B9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57FFA821-17F9-6299-FC16-95EA24E1343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1871F8FD-8B45-3013-CA9C-B146AB9F68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642255EC-ACFE-3E6D-38FD-4EFA42839E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524E6-2FC0-4AD0-B79C-85473C9E6013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9EFFABF7-D330-D50C-8B58-C13C5C4846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547DBFF7-E80A-4626-5BB2-95B9D8A14B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CE5E8-1424-4A1B-95A2-E5BC78F17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55271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F6AF081-206D-41CF-6B74-AD8825A59D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91B750CC-599A-3B37-BBAE-31052192D2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781DBB71-C5CB-96FE-42A5-278A5121E6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14A0BA33-CBAD-F7A8-16ED-9331E66CCF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524E6-2FC0-4AD0-B79C-85473C9E6013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A1DD179C-E54E-FE8C-D348-23BDBF82B9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32BC29E7-718E-5D31-2154-9C4B1EDE5F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CE5E8-1424-4A1B-95A2-E5BC78F17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3659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31A1CB5A-32D7-A400-8722-152AC824F7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4780F599-D121-5DF1-0E61-212CFFC16A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B6DEE72A-54A4-3B09-5618-305F590FDF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E524E6-2FC0-4AD0-B79C-85473C9E6013}" type="datetimeFigureOut">
              <a:rPr kumimoji="1" lang="ja-JP" altLang="en-US" smtClean="0"/>
              <a:t>2024/2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A39435D0-2F0E-1F9B-5963-4ACFFB29B1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3D74DD1D-CB66-5A1A-BB89-95B4F94572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4CE5E8-1424-4A1B-95A2-E5BC78F17A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9931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コンテンツ プレースホルダー 6">
            <a:extLst>
              <a:ext uri="{FF2B5EF4-FFF2-40B4-BE49-F238E27FC236}">
                <a16:creationId xmlns:a16="http://schemas.microsoft.com/office/drawing/2014/main" xmlns="" id="{5C16D538-564B-8F6E-368C-5F6BABAEA878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240139515"/>
              </p:ext>
            </p:extLst>
          </p:nvPr>
        </p:nvGraphicFramePr>
        <p:xfrm>
          <a:off x="141110" y="249810"/>
          <a:ext cx="11746087" cy="63514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95961">
                  <a:extLst>
                    <a:ext uri="{9D8B030D-6E8A-4147-A177-3AD203B41FA5}">
                      <a16:colId xmlns:a16="http://schemas.microsoft.com/office/drawing/2014/main" xmlns="" val="3249686199"/>
                    </a:ext>
                  </a:extLst>
                </a:gridCol>
                <a:gridCol w="809602">
                  <a:extLst>
                    <a:ext uri="{9D8B030D-6E8A-4147-A177-3AD203B41FA5}">
                      <a16:colId xmlns:a16="http://schemas.microsoft.com/office/drawing/2014/main" xmlns="" val="1343049597"/>
                    </a:ext>
                  </a:extLst>
                </a:gridCol>
                <a:gridCol w="59841">
                  <a:extLst>
                    <a:ext uri="{9D8B030D-6E8A-4147-A177-3AD203B41FA5}">
                      <a16:colId xmlns:a16="http://schemas.microsoft.com/office/drawing/2014/main" xmlns="" val="1951836156"/>
                    </a:ext>
                  </a:extLst>
                </a:gridCol>
                <a:gridCol w="485139">
                  <a:extLst>
                    <a:ext uri="{9D8B030D-6E8A-4147-A177-3AD203B41FA5}">
                      <a16:colId xmlns:a16="http://schemas.microsoft.com/office/drawing/2014/main" xmlns="" val="3824886413"/>
                    </a:ext>
                  </a:extLst>
                </a:gridCol>
                <a:gridCol w="398007">
                  <a:extLst>
                    <a:ext uri="{9D8B030D-6E8A-4147-A177-3AD203B41FA5}">
                      <a16:colId xmlns:a16="http://schemas.microsoft.com/office/drawing/2014/main" xmlns="" val="1557352966"/>
                    </a:ext>
                  </a:extLst>
                </a:gridCol>
                <a:gridCol w="1268483">
                  <a:extLst>
                    <a:ext uri="{9D8B030D-6E8A-4147-A177-3AD203B41FA5}">
                      <a16:colId xmlns:a16="http://schemas.microsoft.com/office/drawing/2014/main" xmlns="" val="1143521594"/>
                    </a:ext>
                  </a:extLst>
                </a:gridCol>
                <a:gridCol w="1071676">
                  <a:extLst>
                    <a:ext uri="{9D8B030D-6E8A-4147-A177-3AD203B41FA5}">
                      <a16:colId xmlns:a16="http://schemas.microsoft.com/office/drawing/2014/main" xmlns="" val="2371234797"/>
                    </a:ext>
                  </a:extLst>
                </a:gridCol>
                <a:gridCol w="1140717">
                  <a:extLst>
                    <a:ext uri="{9D8B030D-6E8A-4147-A177-3AD203B41FA5}">
                      <a16:colId xmlns:a16="http://schemas.microsoft.com/office/drawing/2014/main" xmlns="" val="2776955542"/>
                    </a:ext>
                  </a:extLst>
                </a:gridCol>
                <a:gridCol w="900530">
                  <a:extLst>
                    <a:ext uri="{9D8B030D-6E8A-4147-A177-3AD203B41FA5}">
                      <a16:colId xmlns:a16="http://schemas.microsoft.com/office/drawing/2014/main" xmlns="" val="2657985889"/>
                    </a:ext>
                  </a:extLst>
                </a:gridCol>
                <a:gridCol w="989790">
                  <a:extLst>
                    <a:ext uri="{9D8B030D-6E8A-4147-A177-3AD203B41FA5}">
                      <a16:colId xmlns:a16="http://schemas.microsoft.com/office/drawing/2014/main" xmlns="" val="1498776600"/>
                    </a:ext>
                  </a:extLst>
                </a:gridCol>
                <a:gridCol w="738285">
                  <a:extLst>
                    <a:ext uri="{9D8B030D-6E8A-4147-A177-3AD203B41FA5}">
                      <a16:colId xmlns:a16="http://schemas.microsoft.com/office/drawing/2014/main" xmlns="" val="3815102354"/>
                    </a:ext>
                  </a:extLst>
                </a:gridCol>
                <a:gridCol w="849168">
                  <a:extLst>
                    <a:ext uri="{9D8B030D-6E8A-4147-A177-3AD203B41FA5}">
                      <a16:colId xmlns:a16="http://schemas.microsoft.com/office/drawing/2014/main" xmlns="" val="2145925456"/>
                    </a:ext>
                  </a:extLst>
                </a:gridCol>
                <a:gridCol w="869444">
                  <a:extLst>
                    <a:ext uri="{9D8B030D-6E8A-4147-A177-3AD203B41FA5}">
                      <a16:colId xmlns:a16="http://schemas.microsoft.com/office/drawing/2014/main" xmlns="" val="3256502055"/>
                    </a:ext>
                  </a:extLst>
                </a:gridCol>
                <a:gridCol w="869444">
                  <a:extLst>
                    <a:ext uri="{9D8B030D-6E8A-4147-A177-3AD203B41FA5}">
                      <a16:colId xmlns:a16="http://schemas.microsoft.com/office/drawing/2014/main" xmlns="" val="2275514001"/>
                    </a:ext>
                  </a:extLst>
                </a:gridCol>
              </a:tblGrid>
              <a:tr h="232858">
                <a:tc gridSpan="14">
                  <a:txBody>
                    <a:bodyPr/>
                    <a:lstStyle/>
                    <a:p>
                      <a:pPr algn="l" fontAlgn="ctr"/>
                      <a:r>
                        <a:rPr lang="en-US" altLang="ja-JP" sz="1400" b="1" kern="100" dirty="0" smtClean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S1</a:t>
                      </a:r>
                      <a:r>
                        <a:rPr lang="en-US" altLang="ja-JP" sz="1400" b="1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:</a:t>
                      </a:r>
                      <a:r>
                        <a:rPr lang="en-US" altLang="ja-JP" sz="1400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 Characteristics of each institution and ICU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73273857"/>
                  </a:ext>
                </a:extLst>
              </a:tr>
              <a:tr h="23285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Institutions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baseline="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a     </a:t>
                      </a:r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baseline="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b</a:t>
                      </a:r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baseline="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c</a:t>
                      </a:r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baseline="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d</a:t>
                      </a:r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baseline="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e</a:t>
                      </a:r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baseline="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f</a:t>
                      </a:r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baseline="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g</a:t>
                      </a:r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baseline="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h</a:t>
                      </a:r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baseline="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i</a:t>
                      </a:r>
                      <a:endParaRPr lang="ja-JP" sz="1400" b="0" i="0" u="none" strike="noStrike" baseline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61059764"/>
                  </a:ext>
                </a:extLst>
              </a:tr>
              <a:tr h="232858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. of ICU beds, n 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8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7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0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20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6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2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6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4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28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21582679"/>
                  </a:ext>
                </a:extLst>
              </a:tr>
              <a:tr h="232858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. of COVID-19 ICU beds, n 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4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1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250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2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3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7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8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14468173"/>
                  </a:ext>
                </a:extLst>
              </a:tr>
              <a:tr h="232858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. of beds in the </a:t>
                      </a:r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hospital, n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49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30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80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408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640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620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080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865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628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01272621"/>
                  </a:ext>
                </a:extLst>
              </a:tr>
              <a:tr h="586160">
                <a:tc gridSpan="5"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4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rincipal Clinical Department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2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Emer</a:t>
                      </a:r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ja-JP" sz="12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ency </a:t>
                      </a:r>
                      <a:endParaRPr lang="en-US" altLang="ja-JP" sz="1200" u="none" strike="noStrike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r>
                        <a:rPr lang="ja-JP" sz="12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Medicine</a:t>
                      </a:r>
                      <a:endParaRPr 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2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Anesthesiology</a:t>
                      </a:r>
                      <a:endParaRPr 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2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Pulmonary Medicine</a:t>
                      </a:r>
                      <a:endParaRPr 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2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Emerbency Medicine</a:t>
                      </a:r>
                      <a:endParaRPr lang="ja-JP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2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Emer</a:t>
                      </a:r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ja-JP" sz="12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ency Medicine</a:t>
                      </a:r>
                      <a:endParaRPr 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2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Intensive care medicine</a:t>
                      </a:r>
                      <a:endParaRPr 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2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Pulmonary Medicine</a:t>
                      </a:r>
                      <a:endParaRPr 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2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Intensive care medicine</a:t>
                      </a:r>
                      <a:endParaRPr 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2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Intensive care medicine</a:t>
                      </a:r>
                      <a:endParaRPr 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47121053"/>
                  </a:ext>
                </a:extLst>
              </a:tr>
              <a:tr h="232858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Types of ICU models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68175553"/>
                  </a:ext>
                </a:extLst>
              </a:tr>
              <a:tr h="232858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  Closed ICU model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95073927"/>
                  </a:ext>
                </a:extLst>
              </a:tr>
              <a:tr h="232858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  Open ICU model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46831495"/>
                  </a:ext>
                </a:extLst>
              </a:tr>
              <a:tr h="232858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  Intensivist co-management model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400" u="none" strike="noStrike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75902837"/>
                  </a:ext>
                </a:extLst>
              </a:tr>
              <a:tr h="232858">
                <a:tc gridSpan="5"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5033771"/>
                  </a:ext>
                </a:extLst>
              </a:tr>
              <a:tr h="682515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Physician use of HACOR score as a guide for treatment?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214482925"/>
                  </a:ext>
                </a:extLst>
              </a:tr>
              <a:tr h="682515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Physician use ROX index as a guide for treatment?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98495178"/>
                  </a:ext>
                </a:extLst>
              </a:tr>
              <a:tr h="232858">
                <a:tc gridSpan="5">
                  <a:txBody>
                    <a:bodyPr/>
                    <a:lstStyle/>
                    <a:p>
                      <a:pPr algn="l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99695989"/>
                  </a:ext>
                </a:extLst>
              </a:tr>
              <a:tr h="457687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Setting of high flow nasal cannula at 2hour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ja-JP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31618484"/>
                  </a:ext>
                </a:extLst>
              </a:tr>
              <a:tr h="232858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  Oxygen flow (L/min)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6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4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3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3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4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4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4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27791824"/>
                  </a:ext>
                </a:extLst>
              </a:tr>
              <a:tr h="232858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  FiO</a:t>
                      </a:r>
                      <a:r>
                        <a:rPr lang="en-US" altLang="ja-JP" sz="14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2</a:t>
                      </a:r>
                      <a:endParaRPr lang="ja-JP" sz="14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55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4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5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50</a:t>
                      </a:r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737387687"/>
                  </a:ext>
                </a:extLst>
              </a:tr>
              <a:tr h="232858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endParaRPr lang="ja-JP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FFFF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333309581"/>
                  </a:ext>
                </a:extLst>
              </a:tr>
              <a:tr h="682515">
                <a:tc gridSpan="14"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ICU: intensive care unit</a:t>
                      </a:r>
                    </a:p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a: Yokohama Medical center, b: Tohoku University, c: National Defense Medical College, d: Tokyo Metropolitan </a:t>
                      </a:r>
                      <a:r>
                        <a:rPr lang="en-US" altLang="ja-JP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Hiroo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Hospital, e: Saga University, f: Kochi Health Sciences Center , g:Nagoya University, h: Kameda Medical Center, i: </a:t>
                      </a:r>
                      <a:r>
                        <a:rPr lang="en-US" altLang="ja-JP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Jichi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Medical University Saitama Medical Center.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5935965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32481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2">
            <a:extLst>
              <a:ext uri="{FF2B5EF4-FFF2-40B4-BE49-F238E27FC236}">
                <a16:creationId xmlns:a16="http://schemas.microsoft.com/office/drawing/2014/main" xmlns="" id="{2F230AEE-5578-C62C-A4AD-B021F5B59B5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3651211"/>
              </p:ext>
            </p:extLst>
          </p:nvPr>
        </p:nvGraphicFramePr>
        <p:xfrm>
          <a:off x="146671" y="1199828"/>
          <a:ext cx="11832767" cy="4267200"/>
        </p:xfrm>
        <a:graphic>
          <a:graphicData uri="http://schemas.openxmlformats.org/drawingml/2006/table">
            <a:tbl>
              <a:tblPr/>
              <a:tblGrid>
                <a:gridCol w="161668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6357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28017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62907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28017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762907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280176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762907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1280176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762907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1280176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</a:tblGrid>
              <a:tr h="154699">
                <a:tc gridSpan="11">
                  <a:txBody>
                    <a:bodyPr/>
                    <a:lstStyle/>
                    <a:p>
                      <a:pPr marL="63500" marR="6350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1" dirty="0" smtClean="0"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S2</a:t>
                      </a:r>
                      <a:r>
                        <a:rPr kumimoji="1" lang="en-US" altLang="ja-JP" sz="1100" b="1" dirty="0"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: </a:t>
                      </a:r>
                      <a:r>
                        <a:rPr kumimoji="1" lang="en-US" altLang="ja-JP" sz="1100" dirty="0"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Test values at each measurement point and HACOR score and ROX Index</a:t>
                      </a:r>
                      <a:endParaRPr kumimoji="1" lang="ja-JP" altLang="en-US" sz="1100" dirty="0"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endParaRPr sz="1100" b="1" i="0" u="none" cap="none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Arial"/>
                          <a:cs typeface="Arial"/>
                          <a:sym typeface="Arial"/>
                        </a:rPr>
                        <a:t>Visit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Arial"/>
                          <a:cs typeface="Arial"/>
                          <a:sym typeface="Arial"/>
                        </a:rPr>
                        <a:t>Visit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Arial"/>
                          <a:cs typeface="Arial"/>
                          <a:sym typeface="Arial"/>
                        </a:rPr>
                        <a:t>Visit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Arial"/>
                          <a:cs typeface="Arial"/>
                          <a:sym typeface="Arial"/>
                        </a:rPr>
                        <a:t>Visit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Arial"/>
                          <a:cs typeface="Arial"/>
                          <a:sym typeface="Arial"/>
                        </a:rPr>
                        <a:t>Visit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Arial"/>
                          <a:cs typeface="Arial"/>
                          <a:sym typeface="Arial"/>
                        </a:rPr>
                        <a:t>Visit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Arial"/>
                          <a:cs typeface="Arial"/>
                          <a:sym typeface="Arial"/>
                        </a:rPr>
                        <a:t>Visit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Arial"/>
                          <a:cs typeface="Arial"/>
                          <a:sym typeface="Arial"/>
                        </a:rPr>
                        <a:t>Visit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Arial"/>
                          <a:cs typeface="Arial"/>
                          <a:sym typeface="Arial"/>
                        </a:rPr>
                        <a:t>Visit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54699">
                <a:tc>
                  <a:txBody>
                    <a:bodyPr/>
                    <a:lstStyle/>
                    <a:p>
                      <a:pPr marL="63500" marR="63500" algn="l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Characteristic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Observed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2 hour</a:t>
                      </a:r>
                      <a:r>
                        <a:rPr lang="en-US" altLang="ja-JP"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,</a:t>
                      </a:r>
                      <a:r>
                        <a:rPr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 N = 300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Observed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6,</a:t>
                      </a:r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hour,</a:t>
                      </a:r>
                      <a:r>
                        <a:rPr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 N = 274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Observed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2</a:t>
                      </a:r>
                      <a:r>
                        <a:rPr lang="en-US"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 hour</a:t>
                      </a:r>
                      <a:r>
                        <a:rPr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, N = 262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Observed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4</a:t>
                      </a:r>
                      <a:r>
                        <a:rPr lang="en-US"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 </a:t>
                      </a:r>
                      <a:r>
                        <a:rPr lang="en-US" altLang="ja-JP"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hour</a:t>
                      </a:r>
                      <a:r>
                        <a:rPr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,</a:t>
                      </a:r>
                      <a:r>
                        <a:rPr lang="en-US" altLang="ja-JP"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 </a:t>
                      </a:r>
                      <a:r>
                        <a:rPr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N = 225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Observed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  <a:buNone/>
                      </a:pPr>
                      <a:r>
                        <a:rPr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48</a:t>
                      </a:r>
                      <a:r>
                        <a:rPr lang="en-US"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 </a:t>
                      </a:r>
                      <a:r>
                        <a:rPr lang="en-US" altLang="ja-JP"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hour</a:t>
                      </a:r>
                      <a:r>
                        <a:rPr sz="1100" b="1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, N = 168</a:t>
                      </a:r>
                    </a:p>
                  </a:txBody>
                  <a:tcPr marL="0" marR="0" marT="25400" marB="25400" anchor="ctr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>
                          <a:alpha val="100000"/>
                        </a:srgbClr>
                      </a:solidFill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72120">
                <a:tc>
                  <a:txBody>
                    <a:bodyPr/>
                    <a:lstStyle/>
                    <a:p>
                      <a:pPr marL="63500" marR="63500" algn="l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HR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92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80 (70, 91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49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75 (64, 86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47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71 (61, 82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23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72 (62, 82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68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69 (61, 78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72120">
                <a:tc>
                  <a:txBody>
                    <a:bodyPr/>
                    <a:lstStyle/>
                    <a:p>
                      <a:pPr marL="63500" marR="63500" algn="l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GCS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97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5 (15, 15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58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5 (15, 15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46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5 (15, 15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22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5 (15, 15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67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5 (15, 15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72120">
                <a:tc>
                  <a:txBody>
                    <a:bodyPr/>
                    <a:lstStyle/>
                    <a:p>
                      <a:pPr marL="63500" marR="63500" algn="l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RR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88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4 (20, 28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42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2 (20, 26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39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2 (18, 25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18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2 (19, 25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64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2 (20, 25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272120">
                <a:tc>
                  <a:txBody>
                    <a:bodyPr/>
                    <a:lstStyle/>
                    <a:p>
                      <a:pPr marL="63500" marR="63500" algn="l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SpO2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98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94 (92, 97)</a:t>
                      </a:r>
                      <a:endParaRPr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64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96 (92, 97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54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94 (92, 96)</a:t>
                      </a:r>
                      <a:endParaRPr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24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94.0 (92, 96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67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94 (92, 96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272120">
                <a:tc>
                  <a:txBody>
                    <a:bodyPr/>
                    <a:lstStyle/>
                    <a:p>
                      <a:pPr marL="63500" marR="63500" algn="l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P</a:t>
                      </a:r>
                      <a:r>
                        <a:rPr lang="en-US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aO</a:t>
                      </a:r>
                      <a:r>
                        <a:rPr lang="en-US" sz="1100" b="0" i="0" u="none" cap="none" baseline="-25000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</a:t>
                      </a:r>
                      <a:r>
                        <a:rPr lang="en-US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/FiO</a:t>
                      </a:r>
                      <a:r>
                        <a:rPr lang="en-US" altLang="ja-JP" sz="1100" b="0" i="0" u="none" cap="none" baseline="-25000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</a:t>
                      </a:r>
                      <a:endParaRPr sz="1100" b="0" i="0" u="none" cap="none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57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54 (118, 193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17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59 (128, 202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22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70 (126, 217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08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53 (112, 195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86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43 (112, 180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272120">
                <a:tc>
                  <a:txBody>
                    <a:bodyPr/>
                    <a:lstStyle/>
                    <a:p>
                      <a:pPr marL="63500" marR="63500" algn="l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PaCO2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57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35.0 (31.3, 37.0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17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36.0 (32.0, 38.3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22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36.0 (32.4, 39.0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09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34.6 (31.8, 38.0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86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34.5 (31.9, 38.8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9"/>
                  </a:ext>
                </a:extLst>
              </a:tr>
              <a:tr h="272120">
                <a:tc>
                  <a:txBody>
                    <a:bodyPr/>
                    <a:lstStyle/>
                    <a:p>
                      <a:pPr marL="63500" marR="63500" algn="l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pH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57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7.45 (7.44, 7.48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17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7.45 (7.42, 7.47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22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7.44 (7.42, 7.46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09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7.45 (7.42, 7.47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86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7.45 (7.42, 7.48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32"/>
                  </a:ext>
                </a:extLst>
              </a:tr>
              <a:tr h="272120">
                <a:tc>
                  <a:txBody>
                    <a:bodyPr/>
                    <a:lstStyle/>
                    <a:p>
                      <a:pPr marL="63500" marR="63500" algn="l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Flow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99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40 (40, 50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68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40 (40, 50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61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40 (40, 50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24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40 (40, 50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67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40 (40, 50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35"/>
                  </a:ext>
                </a:extLst>
              </a:tr>
              <a:tr h="272120">
                <a:tc>
                  <a:txBody>
                    <a:bodyPr/>
                    <a:lstStyle/>
                    <a:p>
                      <a:pPr marL="63500" marR="63500" algn="l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FiO2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99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0.60 (0.50, 0.60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68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0.60 (0.50, 0.65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61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0.60 (0.50, 0.65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25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0.60 (0.50, 0.65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67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0.60 (0.50, 0.68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38"/>
                  </a:ext>
                </a:extLst>
              </a:tr>
              <a:tr h="272120">
                <a:tc>
                  <a:txBody>
                    <a:bodyPr/>
                    <a:lstStyle/>
                    <a:p>
                      <a:pPr marL="63500" marR="63500" algn="l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HACOR</a:t>
                      </a:r>
                      <a:r>
                        <a:rPr lang="en-US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 Score</a:t>
                      </a:r>
                      <a:endParaRPr sz="1100" b="0" i="0" u="none" cap="none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57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4.0</a:t>
                      </a:r>
                      <a:r>
                        <a:rPr lang="ja-JP" altLang="en-US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 </a:t>
                      </a: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(2.0, 5.0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17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4.0 (2.0, 5.0)</a:t>
                      </a:r>
                      <a:endParaRPr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22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3.5 (0.50, 5.0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09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4.0 (2.0, 5.0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86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4.0 (2.0, 5.0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0" cap="flat" cmpd="sng" algn="ctr">
                      <a:noFill/>
                      <a:prstDash val="soli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41"/>
                  </a:ext>
                </a:extLst>
              </a:tr>
              <a:tr h="272120">
                <a:tc>
                  <a:txBody>
                    <a:bodyPr/>
                    <a:lstStyle/>
                    <a:p>
                      <a:pPr marL="63500" marR="63500" algn="l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ROX</a:t>
                      </a:r>
                      <a:r>
                        <a:rPr lang="en-US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 Index</a:t>
                      </a:r>
                      <a:endParaRPr sz="1100" b="0" i="0" u="none" cap="none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87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7.4 (5.5, 9.1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37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7.4 (6.0, 9.7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38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7.8 (6.2, 10.1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218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7.5 (6.2, 9.8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r>
                        <a:rPr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163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cap="none" dirty="0">
                          <a:solidFill>
                            <a:srgbClr val="000000">
                              <a:alpha val="100000"/>
                            </a:srgb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Arial"/>
                        </a:rPr>
                        <a:t>7.6 (6.2, 9.4)</a:t>
                      </a: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0" cap="flat" cmpd="sng" algn="ctr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>
                        <a:alpha val="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85602802"/>
                  </a:ext>
                </a:extLst>
              </a:tr>
              <a:tr h="272120">
                <a:tc gridSpan="11">
                  <a:txBody>
                    <a:bodyPr/>
                    <a:lstStyle/>
                    <a:p>
                      <a:pPr marL="63500" marR="6350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ta are shown as median (interquartile range). </a:t>
                      </a:r>
                      <a:r>
                        <a:rPr lang="en-US" altLang="ja-JP" sz="1100" kern="0" dirty="0">
                          <a:solidFill>
                            <a:srgbClr val="21212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iO</a:t>
                      </a:r>
                      <a:r>
                        <a:rPr lang="en-US" altLang="ja-JP" sz="1100" kern="0" baseline="-25000" dirty="0">
                          <a:solidFill>
                            <a:srgbClr val="21212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 </a:t>
                      </a:r>
                      <a:r>
                        <a:rPr lang="en-US" altLang="ja-JP" sz="1100" kern="0" dirty="0">
                          <a:solidFill>
                            <a:srgbClr val="21212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:fraction of inspired oxygen; </a:t>
                      </a:r>
                      <a:r>
                        <a:rPr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S: Glasgow coma scale; HR: heart rate; RR: respiratory rate</a:t>
                      </a:r>
                      <a:r>
                        <a:rPr lang="en-US" altLang="ja-JP" sz="1100" kern="0" dirty="0">
                          <a:solidFill>
                            <a:srgbClr val="21212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; </a:t>
                      </a:r>
                      <a:r>
                        <a:rPr lang="en-US" altLang="ja-JP" sz="1100" kern="0" dirty="0">
                          <a:solidFill>
                            <a:srgbClr val="212121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</a:rPr>
                        <a:t>SpO</a:t>
                      </a:r>
                      <a:r>
                        <a:rPr lang="en-US" altLang="ja-JP" sz="1100" kern="0" baseline="-25000" dirty="0">
                          <a:solidFill>
                            <a:srgbClr val="212121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</a:rPr>
                        <a:t>2 </a:t>
                      </a:r>
                      <a:r>
                        <a:rPr lang="en-US" altLang="ja-JP" sz="1100" kern="0" dirty="0">
                          <a:solidFill>
                            <a:srgbClr val="21212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:</a:t>
                      </a:r>
                      <a:r>
                        <a:rPr lang="en-US" altLang="ja-JP" sz="1100" dirty="0">
                          <a:solidFill>
                            <a:srgbClr val="212121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</a:rPr>
                        <a:t>oxygen saturation</a:t>
                      </a:r>
                      <a:endParaRPr kumimoji="1" lang="ja-JP" altLang="en-US" sz="1100" dirty="0"/>
                    </a:p>
                    <a:p>
                      <a:pPr marL="63500" marR="6350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endParaRPr sz="1100" b="0" i="0" u="none" cap="none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cap="none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endParaRPr sz="1100" b="0" i="0" u="none" cap="none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cap="none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endParaRPr sz="1100" b="0" i="0" u="none" cap="none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cap="none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endParaRPr sz="1100" b="0" i="0" u="none" cap="none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cap="none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algn="ctr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None/>
                      </a:pPr>
                      <a:endParaRPr sz="1100" b="0" i="0" u="none" cap="none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>
                        <a:alpha val="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500"/>
                        </a:spcBef>
                        <a:spcAft>
                          <a:spcPts val="5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cap="none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Arial"/>
                      </a:endParaRPr>
                    </a:p>
                  </a:txBody>
                  <a:tcPr marL="0" marR="0" marT="63500" marB="63500">
                    <a:lnL w="0" cap="flat" cmpd="sng" algn="ctr">
                      <a:noFill/>
                      <a:prstDash val="solid"/>
                    </a:lnL>
                    <a:lnR w="0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>
                        <a:alpha val="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0524258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218919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715051A8-6217-C41F-889B-BCC893DFAD67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811031708"/>
              </p:ext>
            </p:extLst>
          </p:nvPr>
        </p:nvGraphicFramePr>
        <p:xfrm>
          <a:off x="1574359" y="592592"/>
          <a:ext cx="7747194" cy="4996630"/>
        </p:xfrm>
        <a:graphic>
          <a:graphicData uri="http://schemas.openxmlformats.org/drawingml/2006/table">
            <a:tbl>
              <a:tblPr/>
              <a:tblGrid>
                <a:gridCol w="4379657">
                  <a:extLst>
                    <a:ext uri="{9D8B030D-6E8A-4147-A177-3AD203B41FA5}">
                      <a16:colId xmlns:a16="http://schemas.microsoft.com/office/drawing/2014/main" xmlns="" val="1509784723"/>
                    </a:ext>
                  </a:extLst>
                </a:gridCol>
                <a:gridCol w="2000376">
                  <a:extLst>
                    <a:ext uri="{9D8B030D-6E8A-4147-A177-3AD203B41FA5}">
                      <a16:colId xmlns:a16="http://schemas.microsoft.com/office/drawing/2014/main" xmlns="" val="383651668"/>
                    </a:ext>
                  </a:extLst>
                </a:gridCol>
                <a:gridCol w="1367161">
                  <a:extLst>
                    <a:ext uri="{9D8B030D-6E8A-4147-A177-3AD203B41FA5}">
                      <a16:colId xmlns:a16="http://schemas.microsoft.com/office/drawing/2014/main" xmlns="" val="2148380891"/>
                    </a:ext>
                  </a:extLst>
                </a:gridCol>
              </a:tblGrid>
              <a:tr h="365342">
                <a:tc gridSpan="3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1" kern="100" dirty="0" smtClean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S3</a:t>
                      </a:r>
                      <a:r>
                        <a:rPr lang="en-US" altLang="ja-JP" sz="1600" b="1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: </a:t>
                      </a:r>
                      <a:r>
                        <a:rPr lang="en-US" altLang="ja-JP" sz="1600" dirty="0"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linical important intubation and treatment failure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l"/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just"/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just"/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411761000"/>
                  </a:ext>
                </a:extLst>
              </a:tr>
              <a:tr h="365342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Outcome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umber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ja-JP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Overall</a:t>
                      </a:r>
                    </a:p>
                    <a:p>
                      <a:pPr algn="just"/>
                      <a:r>
                        <a:rPr lang="en-US" altLang="ja-JP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=300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56819389"/>
                  </a:ext>
                </a:extLst>
              </a:tr>
              <a:tr h="365342">
                <a:tc>
                  <a:txBody>
                    <a:bodyPr/>
                    <a:lstStyle/>
                    <a:p>
                      <a:pPr algn="just"/>
                      <a:r>
                        <a:rPr lang="en-US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Time to intubation, hour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36*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27 (13 to 72)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97456441"/>
                  </a:ext>
                </a:extLst>
              </a:tr>
              <a:tr h="365342">
                <a:tc>
                  <a:txBody>
                    <a:bodyPr/>
                    <a:lstStyle/>
                    <a:p>
                      <a:pPr algn="just"/>
                      <a:r>
                        <a:rPr lang="en-US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Clinically important intubation within day 7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300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600" kern="10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80 (27%)</a:t>
                      </a:r>
                      <a:endParaRPr lang="ja-JP" sz="1600" kern="10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32910656"/>
                  </a:ext>
                </a:extLst>
              </a:tr>
              <a:tr h="365342">
                <a:tc>
                  <a:txBody>
                    <a:bodyPr/>
                    <a:lstStyle/>
                    <a:p>
                      <a:pPr algn="just"/>
                      <a:r>
                        <a:rPr lang="en-US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Clinically </a:t>
                      </a:r>
                      <a:r>
                        <a:rPr lang="en-US" altLang="ja-JP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importan</a:t>
                      </a:r>
                      <a:r>
                        <a:rPr lang="en-US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t intubation within day 28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600" kern="10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300</a:t>
                      </a:r>
                      <a:endParaRPr lang="ja-JP" sz="1600" kern="10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85 (28%)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84086150"/>
                  </a:ext>
                </a:extLst>
              </a:tr>
              <a:tr h="365342">
                <a:tc>
                  <a:txBody>
                    <a:bodyPr/>
                    <a:lstStyle/>
                    <a:p>
                      <a:pPr algn="just"/>
                      <a:r>
                        <a:rPr lang="en-US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Treatment failure within day 7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300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81 (27%)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69301975"/>
                  </a:ext>
                </a:extLst>
              </a:tr>
              <a:tr h="365342">
                <a:tc>
                  <a:txBody>
                    <a:bodyPr/>
                    <a:lstStyle/>
                    <a:p>
                      <a:pPr algn="just"/>
                      <a:r>
                        <a:rPr lang="en-US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Treatment failure within day 28 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600" kern="10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300</a:t>
                      </a:r>
                      <a:endParaRPr lang="ja-JP" sz="1600" kern="10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600" kern="100" dirty="0"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89 (30%) </a:t>
                      </a:r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0653890"/>
                  </a:ext>
                </a:extLst>
              </a:tr>
              <a:tr h="365342">
                <a:tc gridSpan="3">
                  <a:txBody>
                    <a:bodyPr/>
                    <a:lstStyle/>
                    <a:p>
                      <a:r>
                        <a:rPr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ta are shown as n (%) or median (interquartile range).</a:t>
                      </a:r>
                    </a:p>
                    <a:p>
                      <a:r>
                        <a:rPr lang="en-US" altLang="ja-JP" sz="1600" dirty="0">
                          <a:latin typeface="Times New Roman" panose="02020603050405020304" pitchFamily="18" charset="0"/>
                          <a:ea typeface="游明朝" panose="02020400000000000000" pitchFamily="18" charset="-128"/>
                        </a:rPr>
                        <a:t>C</a:t>
                      </a:r>
                      <a:r>
                        <a:rPr lang="en-US" altLang="ja-JP" sz="16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</a:rPr>
                        <a:t>linically important  intubation was defined as  one that met at least one of the following criteria: loss of consciousness or impaired consciousness (Glasgow Coma Scale &lt; 8), hypotension (systolic arterial blood pressure &lt; 90 mmHg or mean arterial blood pressure &lt; 65 mmHg), respiratory rate &gt; 40 /min, hypoxia with SpO</a:t>
                      </a:r>
                      <a:r>
                        <a:rPr lang="en-US" altLang="ja-JP" sz="1600" baseline="-250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</a:rPr>
                        <a:t>2</a:t>
                      </a:r>
                      <a:r>
                        <a:rPr lang="en-US" altLang="ja-JP" sz="16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</a:rPr>
                        <a:t> &lt; 92% despite FiO</a:t>
                      </a:r>
                      <a:r>
                        <a:rPr lang="en-US" altLang="ja-JP" sz="1600" baseline="-250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</a:rPr>
                        <a:t>2</a:t>
                      </a:r>
                      <a:r>
                        <a:rPr lang="en-US" altLang="ja-JP" sz="16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</a:rPr>
                        <a:t> 1.0 or pH &lt; 7.35 by blood gas analysis despite FiO</a:t>
                      </a:r>
                      <a:r>
                        <a:rPr lang="en-US" altLang="ja-JP" sz="1600" baseline="-250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</a:rPr>
                        <a:t>2</a:t>
                      </a:r>
                      <a:r>
                        <a:rPr lang="en-US" altLang="ja-JP" sz="16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</a:rPr>
                        <a:t> 1.0.</a:t>
                      </a:r>
                      <a:endParaRPr lang="en-US" altLang="ja-JP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en-US" altLang="ja-JP" sz="16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</a:rPr>
                        <a:t>Treatment failure was defined as either intubation or death within 7 days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*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alculated only for intubated patients</a:t>
                      </a:r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  <a:p>
                      <a:endParaRPr lang="en-US" altLang="ja-JP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just"/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just"/>
                      <a:endParaRPr lang="ja-JP" sz="1600" kern="100" dirty="0"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2049396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875613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6205A436-DCE7-20F5-D531-481451FF154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806608890"/>
              </p:ext>
            </p:extLst>
          </p:nvPr>
        </p:nvGraphicFramePr>
        <p:xfrm>
          <a:off x="545493" y="2387286"/>
          <a:ext cx="11065785" cy="2743200"/>
        </p:xfrm>
        <a:graphic>
          <a:graphicData uri="http://schemas.openxmlformats.org/drawingml/2006/table">
            <a:tbl>
              <a:tblPr/>
              <a:tblGrid>
                <a:gridCol w="958977">
                  <a:extLst>
                    <a:ext uri="{9D8B030D-6E8A-4147-A177-3AD203B41FA5}">
                      <a16:colId xmlns:a16="http://schemas.microsoft.com/office/drawing/2014/main" xmlns="" val="3038130669"/>
                    </a:ext>
                  </a:extLst>
                </a:gridCol>
                <a:gridCol w="4000687">
                  <a:extLst>
                    <a:ext uri="{9D8B030D-6E8A-4147-A177-3AD203B41FA5}">
                      <a16:colId xmlns:a16="http://schemas.microsoft.com/office/drawing/2014/main" xmlns="" val="1675792954"/>
                    </a:ext>
                  </a:extLst>
                </a:gridCol>
                <a:gridCol w="4000687">
                  <a:extLst>
                    <a:ext uri="{9D8B030D-6E8A-4147-A177-3AD203B41FA5}">
                      <a16:colId xmlns:a16="http://schemas.microsoft.com/office/drawing/2014/main" xmlns="" val="2455301111"/>
                    </a:ext>
                  </a:extLst>
                </a:gridCol>
                <a:gridCol w="2105434">
                  <a:extLst>
                    <a:ext uri="{9D8B030D-6E8A-4147-A177-3AD203B41FA5}">
                      <a16:colId xmlns:a16="http://schemas.microsoft.com/office/drawing/2014/main" xmlns="" val="4086029988"/>
                    </a:ext>
                  </a:extLst>
                </a:gridCol>
              </a:tblGrid>
              <a:tr h="228600">
                <a:tc gridSpan="4">
                  <a:txBody>
                    <a:bodyPr/>
                    <a:lstStyle/>
                    <a:p>
                      <a:r>
                        <a:rPr lang="en-US" altLang="ja-JP" sz="1600" b="1" kern="100" dirty="0" smtClean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S4 </a:t>
                      </a:r>
                      <a:r>
                        <a:rPr lang="en-US" altLang="ja-JP" sz="1600" b="1" kern="100" dirty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: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The area under the receiver operating characteristic curve of each predictions for  the outcomes, which were clinically important intubation or death within 7 days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69056458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Time poin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HACOR score</a:t>
                      </a:r>
                      <a:b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</a:br>
                      <a:r>
                        <a:rPr kumimoji="1" lang="en-US" altLang="ja-JP" sz="1600" dirty="0"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AUROC</a:t>
                      </a:r>
                      <a:r>
                        <a:rPr kumimoji="1" lang="ja-JP" altLang="en-US" sz="1600" dirty="0"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ROX Index</a:t>
                      </a:r>
                      <a:b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</a:br>
                      <a:r>
                        <a:rPr kumimoji="1" lang="en-US" altLang="ja-JP" sz="1600" dirty="0"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AUROC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P-value*</a:t>
                      </a:r>
                      <a:b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</a:b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(HACOR vs ROX 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0923688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 hour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5 (0.55 to 0.75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3 (0.56 to 0.70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2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3927814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6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ur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57 (0.46 to 0.67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5 (0.57 to 0.73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04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193003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2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ur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9 (0.59 to 0.78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3 (0.65 to 0.80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3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2855131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24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ur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7 (0.56 to 0.78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4 (0.67 to 0.82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0753937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48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ur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3 (0.60 to 0.86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6 (0.66 to 0.87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8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17667933"/>
                  </a:ext>
                </a:extLst>
              </a:tr>
              <a:tr h="228600">
                <a:tc gridSpan="4">
                  <a:txBody>
                    <a:bodyPr/>
                    <a:lstStyle/>
                    <a:p>
                      <a:r>
                        <a:rPr lang="en-US" altLang="ja-JP" sz="16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UROC:</a:t>
                      </a:r>
                      <a:r>
                        <a:rPr lang="en-US" altLang="ja-JP" sz="1600" kern="0" dirty="0">
                          <a:solidFill>
                            <a:srgbClr val="21212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the area under the receiver operating characteristic curve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CI: confidence interval</a:t>
                      </a:r>
                    </a:p>
                    <a:p>
                      <a:r>
                        <a:rPr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De-long test </a:t>
                      </a:r>
                      <a:endParaRPr kumimoji="1" lang="en-US" altLang="ja-JP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910216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644596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コンテンツ プレースホルダー 3">
            <a:extLst>
              <a:ext uri="{FF2B5EF4-FFF2-40B4-BE49-F238E27FC236}">
                <a16:creationId xmlns:a16="http://schemas.microsoft.com/office/drawing/2014/main" xmlns="" id="{F6815645-33C6-FDE1-E52C-50747808236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4521429"/>
              </p:ext>
            </p:extLst>
          </p:nvPr>
        </p:nvGraphicFramePr>
        <p:xfrm>
          <a:off x="545493" y="2145986"/>
          <a:ext cx="11389332" cy="2978464"/>
        </p:xfrm>
        <a:graphic>
          <a:graphicData uri="http://schemas.openxmlformats.org/drawingml/2006/table">
            <a:tbl>
              <a:tblPr/>
              <a:tblGrid>
                <a:gridCol w="987016">
                  <a:extLst>
                    <a:ext uri="{9D8B030D-6E8A-4147-A177-3AD203B41FA5}">
                      <a16:colId xmlns:a16="http://schemas.microsoft.com/office/drawing/2014/main" xmlns="" val="3038130669"/>
                    </a:ext>
                  </a:extLst>
                </a:gridCol>
                <a:gridCol w="4117661">
                  <a:extLst>
                    <a:ext uri="{9D8B030D-6E8A-4147-A177-3AD203B41FA5}">
                      <a16:colId xmlns:a16="http://schemas.microsoft.com/office/drawing/2014/main" xmlns="" val="1675792954"/>
                    </a:ext>
                  </a:extLst>
                </a:gridCol>
                <a:gridCol w="4117661">
                  <a:extLst>
                    <a:ext uri="{9D8B030D-6E8A-4147-A177-3AD203B41FA5}">
                      <a16:colId xmlns:a16="http://schemas.microsoft.com/office/drawing/2014/main" xmlns="" val="2455301111"/>
                    </a:ext>
                  </a:extLst>
                </a:gridCol>
                <a:gridCol w="2166994">
                  <a:extLst>
                    <a:ext uri="{9D8B030D-6E8A-4147-A177-3AD203B41FA5}">
                      <a16:colId xmlns:a16="http://schemas.microsoft.com/office/drawing/2014/main" xmlns="" val="4086029988"/>
                    </a:ext>
                  </a:extLst>
                </a:gridCol>
              </a:tblGrid>
              <a:tr h="537778">
                <a:tc gridSpan="4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1" kern="100" dirty="0" smtClean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S5 </a:t>
                      </a:r>
                      <a:r>
                        <a:rPr kumimoji="1" lang="en-US" altLang="ja-JP" sz="1600" b="1" dirty="0"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: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The area under the receiver operating characteristic curve of each predictions for excluding facilities that used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ROX index as a guide for treatment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690564584"/>
                  </a:ext>
                </a:extLst>
              </a:tr>
              <a:tr h="53777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Time poin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HACOR score</a:t>
                      </a:r>
                      <a:b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</a:br>
                      <a:r>
                        <a:rPr kumimoji="1" lang="en-US" altLang="ja-JP" sz="1600" dirty="0"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AUROC</a:t>
                      </a:r>
                      <a:r>
                        <a:rPr kumimoji="1" lang="ja-JP" altLang="en-US" sz="1600" dirty="0"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ROX index</a:t>
                      </a:r>
                      <a:b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</a:br>
                      <a:r>
                        <a:rPr kumimoji="1" lang="en-US" altLang="ja-JP" sz="1600" dirty="0"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AUROC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(95% CI)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P-value*</a:t>
                      </a:r>
                      <a:b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</a:b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(HACOR vs ROX 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09236887"/>
                  </a:ext>
                </a:extLst>
              </a:tr>
              <a:tr h="273026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 hour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4 (0.52 to 0.76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1 (0.53 to 0.69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5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39278144"/>
                  </a:ext>
                </a:extLst>
              </a:tr>
              <a:tr h="27302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6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ur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55 (0.44 to 0.68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3 (0.54 to 0.72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0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1930033"/>
                  </a:ext>
                </a:extLst>
              </a:tr>
              <a:tr h="27302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2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ur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6 (0.55 to 0.77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1 (0.63 to 0.79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3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28551311"/>
                  </a:ext>
                </a:extLst>
              </a:tr>
              <a:tr h="27302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24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ur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7 (0.54 to 0.79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4 (0.66 to 0.82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07539372"/>
                  </a:ext>
                </a:extLst>
              </a:tr>
              <a:tr h="27302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48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ur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2 (0.59 to 0.85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6 (0.66 to 0.87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0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17667933"/>
                  </a:ext>
                </a:extLst>
              </a:tr>
              <a:tr h="537778">
                <a:tc gridSpan="4">
                  <a:txBody>
                    <a:bodyPr/>
                    <a:lstStyle/>
                    <a:p>
                      <a:r>
                        <a:rPr lang="en-US" altLang="ja-JP" sz="16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UROC:</a:t>
                      </a:r>
                      <a:r>
                        <a:rPr lang="en-US" altLang="ja-JP" sz="1600" kern="0" dirty="0">
                          <a:solidFill>
                            <a:srgbClr val="21212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the area under the receiver operating characteristic curve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CI: confidence interval</a:t>
                      </a:r>
                    </a:p>
                    <a:p>
                      <a:r>
                        <a:rPr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De-long test </a:t>
                      </a:r>
                      <a:endParaRPr kumimoji="1" lang="en-US" altLang="ja-JP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910216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222319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xmlns="" id="{A7D2F068-4773-2D30-7E32-E92D6B51594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1926881"/>
              </p:ext>
            </p:extLst>
          </p:nvPr>
        </p:nvGraphicFramePr>
        <p:xfrm>
          <a:off x="87464" y="1944851"/>
          <a:ext cx="11342537" cy="3236502"/>
        </p:xfrm>
        <a:graphic>
          <a:graphicData uri="http://schemas.openxmlformats.org/drawingml/2006/table">
            <a:tbl>
              <a:tblPr/>
              <a:tblGrid>
                <a:gridCol w="1253329">
                  <a:extLst>
                    <a:ext uri="{9D8B030D-6E8A-4147-A177-3AD203B41FA5}">
                      <a16:colId xmlns:a16="http://schemas.microsoft.com/office/drawing/2014/main" xmlns="" val="1075585538"/>
                    </a:ext>
                  </a:extLst>
                </a:gridCol>
                <a:gridCol w="1509777">
                  <a:extLst>
                    <a:ext uri="{9D8B030D-6E8A-4147-A177-3AD203B41FA5}">
                      <a16:colId xmlns:a16="http://schemas.microsoft.com/office/drawing/2014/main" xmlns="" val="2612887552"/>
                    </a:ext>
                  </a:extLst>
                </a:gridCol>
                <a:gridCol w="1140882">
                  <a:extLst>
                    <a:ext uri="{9D8B030D-6E8A-4147-A177-3AD203B41FA5}">
                      <a16:colId xmlns:a16="http://schemas.microsoft.com/office/drawing/2014/main" xmlns="" val="2356857893"/>
                    </a:ext>
                  </a:extLst>
                </a:gridCol>
                <a:gridCol w="1346241">
                  <a:extLst>
                    <a:ext uri="{9D8B030D-6E8A-4147-A177-3AD203B41FA5}">
                      <a16:colId xmlns:a16="http://schemas.microsoft.com/office/drawing/2014/main" xmlns="" val="2143241277"/>
                    </a:ext>
                  </a:extLst>
                </a:gridCol>
                <a:gridCol w="1152291">
                  <a:extLst>
                    <a:ext uri="{9D8B030D-6E8A-4147-A177-3AD203B41FA5}">
                      <a16:colId xmlns:a16="http://schemas.microsoft.com/office/drawing/2014/main" xmlns="" val="1323387811"/>
                    </a:ext>
                  </a:extLst>
                </a:gridCol>
                <a:gridCol w="1631460">
                  <a:extLst>
                    <a:ext uri="{9D8B030D-6E8A-4147-A177-3AD203B41FA5}">
                      <a16:colId xmlns:a16="http://schemas.microsoft.com/office/drawing/2014/main" xmlns="" val="1021713719"/>
                    </a:ext>
                  </a:extLst>
                </a:gridCol>
                <a:gridCol w="1186517">
                  <a:extLst>
                    <a:ext uri="{9D8B030D-6E8A-4147-A177-3AD203B41FA5}">
                      <a16:colId xmlns:a16="http://schemas.microsoft.com/office/drawing/2014/main" xmlns="" val="3554507712"/>
                    </a:ext>
                  </a:extLst>
                </a:gridCol>
                <a:gridCol w="969749">
                  <a:extLst>
                    <a:ext uri="{9D8B030D-6E8A-4147-A177-3AD203B41FA5}">
                      <a16:colId xmlns:a16="http://schemas.microsoft.com/office/drawing/2014/main" xmlns="" val="2120463910"/>
                    </a:ext>
                  </a:extLst>
                </a:gridCol>
                <a:gridCol w="1152291">
                  <a:extLst>
                    <a:ext uri="{9D8B030D-6E8A-4147-A177-3AD203B41FA5}">
                      <a16:colId xmlns:a16="http://schemas.microsoft.com/office/drawing/2014/main" xmlns="" val="1997266484"/>
                    </a:ext>
                  </a:extLst>
                </a:gridCol>
              </a:tblGrid>
              <a:tr h="198616">
                <a:tc gridSpan="9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1" kern="100" dirty="0" smtClean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  <a:cs typeface="Times New Roman" panose="02020603050405020304" pitchFamily="18" charset="0"/>
                        </a:rPr>
                        <a:t>S6 </a:t>
                      </a:r>
                      <a:r>
                        <a:rPr kumimoji="1" lang="en-US" altLang="ja-JP" sz="1600" b="1" dirty="0"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: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Discrimination of the HACOR score and ROX index predictions excluding facilities that used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use ROX index as a guide for treatment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53708748"/>
                  </a:ext>
                </a:extLst>
              </a:tr>
              <a:tr h="198616">
                <a:tc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HACOR score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ROX index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10901489"/>
                  </a:ext>
                </a:extLst>
              </a:tr>
              <a:tr h="1986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Time poin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Sensitivity 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Specificity 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PPV 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PV 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Sensitivity 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Specificity 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PPV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NPV 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560020532"/>
                  </a:ext>
                </a:extLst>
              </a:tr>
              <a:tr h="198616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 hour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17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88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35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3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046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99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0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2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42066289"/>
                  </a:ext>
                </a:extLst>
              </a:tr>
              <a:tr h="1986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6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ur 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073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93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28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3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073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99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7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67647988"/>
                  </a:ext>
                </a:extLst>
              </a:tr>
              <a:tr h="1986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2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ur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11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92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33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3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037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99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67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3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21016221"/>
                  </a:ext>
                </a:extLst>
              </a:tr>
              <a:tr h="1986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24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ur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16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88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32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11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7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18724981"/>
                  </a:ext>
                </a:extLst>
              </a:tr>
              <a:tr h="1986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48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ur </a:t>
                      </a:r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32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90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47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83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18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98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71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0.81</a:t>
                      </a: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30990994"/>
                  </a:ext>
                </a:extLst>
              </a:tr>
              <a:tr h="198616">
                <a:tc gridSpan="9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dirty="0"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NPV</a:t>
                      </a:r>
                      <a:r>
                        <a:rPr lang="en-US" altLang="ja-JP" sz="16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:</a:t>
                      </a:r>
                      <a:r>
                        <a:rPr lang="en-US" altLang="ja-JP" sz="1600" kern="0" dirty="0">
                          <a:solidFill>
                            <a:srgbClr val="21212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600" b="0" i="0" dirty="0">
                          <a:solidFill>
                            <a:srgbClr val="4D5156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gative predictive value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</a:t>
                      </a:r>
                      <a:r>
                        <a:rPr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V</a:t>
                      </a:r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</a:t>
                      </a:r>
                      <a:r>
                        <a:rPr kumimoji="1" lang="en-US" altLang="ja-JP" sz="1600" dirty="0">
                          <a:solidFill>
                            <a:srgbClr val="4D5156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</a:t>
                      </a:r>
                      <a:r>
                        <a:rPr lang="en-US" altLang="ja-JP" sz="1600" b="0" i="0" dirty="0">
                          <a:solidFill>
                            <a:srgbClr val="4D5156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ve predictive value</a:t>
                      </a:r>
                    </a:p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16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21212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we evaluated the predictive performance, including sensitivity, specificity, and positive and negative predicted values, utilizing the threshold criteria, which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e HACOR score versus those for the ROX index as follows: &gt;5 versus &lt;2.85 at 2 h; &gt;5 versus &lt;3.47 at 6 h; and &gt;5 versus &lt;3.85 at 12 h, respectively. Because of limited evidence regarding the cutoff points at 24 and 48 h, we employed the threshold established at 12 h. 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621" marR="6621" marT="66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080867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011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59</TotalTime>
  <Words>1373</Words>
  <Application>Microsoft Office PowerPoint</Application>
  <PresentationFormat>Widescreen</PresentationFormat>
  <Paragraphs>414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ＭＳ Ｐゴシック</vt:lpstr>
      <vt:lpstr>游ゴシック</vt:lpstr>
      <vt:lpstr>游ゴシック Light</vt:lpstr>
      <vt:lpstr>Arial</vt:lpstr>
      <vt:lpstr>メイリオ</vt:lpstr>
      <vt:lpstr>ＭＳ 明朝</vt:lpstr>
      <vt:lpstr>Times New Roman</vt:lpstr>
      <vt:lpstr>游明朝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and Figure</dc:title>
  <dc:creator>岡野 弘</dc:creator>
  <cp:lastModifiedBy>Saranya M.</cp:lastModifiedBy>
  <cp:revision>71</cp:revision>
  <dcterms:created xsi:type="dcterms:W3CDTF">2023-04-01T03:14:00Z</dcterms:created>
  <dcterms:modified xsi:type="dcterms:W3CDTF">2024-02-10T07:58:48Z</dcterms:modified>
</cp:coreProperties>
</file>